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73152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2" d="100"/>
          <a:sy n="42" d="100"/>
        </p:scale>
        <p:origin x="262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iuddin, Sayed Golam" userId="5c5f2d06-5da7-4463-8de7-92cf1264e307" providerId="ADAL" clId="{C4BBB0E8-4342-43A6-8BB1-18070781D58E}"/>
    <pc:docChg chg="modSld modMainMaster">
      <pc:chgData name="Mohiuddin, Sayed Golam" userId="5c5f2d06-5da7-4463-8de7-92cf1264e307" providerId="ADAL" clId="{C4BBB0E8-4342-43A6-8BB1-18070781D58E}" dt="2023-08-03T22:35:06.173" v="15" actId="1076"/>
      <pc:docMkLst>
        <pc:docMk/>
      </pc:docMkLst>
      <pc:sldChg chg="addSp modSp mod">
        <pc:chgData name="Mohiuddin, Sayed Golam" userId="5c5f2d06-5da7-4463-8de7-92cf1264e307" providerId="ADAL" clId="{C4BBB0E8-4342-43A6-8BB1-18070781D58E}" dt="2023-08-03T22:35:06.173" v="15" actId="1076"/>
        <pc:sldMkLst>
          <pc:docMk/>
          <pc:sldMk cId="3380178157" sldId="256"/>
        </pc:sldMkLst>
        <pc:spChg chg="mod">
          <ac:chgData name="Mohiuddin, Sayed Golam" userId="5c5f2d06-5da7-4463-8de7-92cf1264e307" providerId="ADAL" clId="{C4BBB0E8-4342-43A6-8BB1-18070781D58E}" dt="2023-08-03T22:34:40.972" v="9" actId="1037"/>
          <ac:spMkLst>
            <pc:docMk/>
            <pc:sldMk cId="3380178157" sldId="256"/>
            <ac:spMk id="3" creationId="{91F1FF6E-DEC1-4B46-9D5F-5643F7DDD8BD}"/>
          </ac:spMkLst>
        </pc:spChg>
        <pc:spChg chg="mod">
          <ac:chgData name="Mohiuddin, Sayed Golam" userId="5c5f2d06-5da7-4463-8de7-92cf1264e307" providerId="ADAL" clId="{C4BBB0E8-4342-43A6-8BB1-18070781D58E}" dt="2023-08-03T22:34:40.972" v="9" actId="1037"/>
          <ac:spMkLst>
            <pc:docMk/>
            <pc:sldMk cId="3380178157" sldId="256"/>
            <ac:spMk id="6" creationId="{AAD041CD-CC84-4981-B730-2DE437A59F01}"/>
          </ac:spMkLst>
        </pc:spChg>
        <pc:spChg chg="mod">
          <ac:chgData name="Mohiuddin, Sayed Golam" userId="5c5f2d06-5da7-4463-8de7-92cf1264e307" providerId="ADAL" clId="{C4BBB0E8-4342-43A6-8BB1-18070781D58E}" dt="2023-08-03T22:34:40.972" v="9" actId="1037"/>
          <ac:spMkLst>
            <pc:docMk/>
            <pc:sldMk cId="3380178157" sldId="256"/>
            <ac:spMk id="7" creationId="{502948E1-3CC3-4C30-AB34-411CDA9C7A0B}"/>
          </ac:spMkLst>
        </pc:spChg>
        <pc:spChg chg="mod">
          <ac:chgData name="Mohiuddin, Sayed Golam" userId="5c5f2d06-5da7-4463-8de7-92cf1264e307" providerId="ADAL" clId="{C4BBB0E8-4342-43A6-8BB1-18070781D58E}" dt="2023-08-03T22:34:40.972" v="9" actId="1037"/>
          <ac:spMkLst>
            <pc:docMk/>
            <pc:sldMk cId="3380178157" sldId="256"/>
            <ac:spMk id="8" creationId="{0E9D8E53-0110-47BF-B577-29B95CC09210}"/>
          </ac:spMkLst>
        </pc:spChg>
        <pc:spChg chg="add mod">
          <ac:chgData name="Mohiuddin, Sayed Golam" userId="5c5f2d06-5da7-4463-8de7-92cf1264e307" providerId="ADAL" clId="{C4BBB0E8-4342-43A6-8BB1-18070781D58E}" dt="2023-08-03T22:35:06.173" v="15" actId="1076"/>
          <ac:spMkLst>
            <pc:docMk/>
            <pc:sldMk cId="3380178157" sldId="256"/>
            <ac:spMk id="9" creationId="{ECA20C70-D232-4B8D-92AA-3F4EDDEA3F19}"/>
          </ac:spMkLst>
        </pc:spChg>
        <pc:picChg chg="mod">
          <ac:chgData name="Mohiuddin, Sayed Golam" userId="5c5f2d06-5da7-4463-8de7-92cf1264e307" providerId="ADAL" clId="{C4BBB0E8-4342-43A6-8BB1-18070781D58E}" dt="2023-08-03T22:34:40.972" v="9" actId="1037"/>
          <ac:picMkLst>
            <pc:docMk/>
            <pc:sldMk cId="3380178157" sldId="256"/>
            <ac:picMk id="2" creationId="{87D1BEDB-1CDA-4830-9A5C-EDF80637D42F}"/>
          </ac:picMkLst>
        </pc:picChg>
        <pc:picChg chg="mod">
          <ac:chgData name="Mohiuddin, Sayed Golam" userId="5c5f2d06-5da7-4463-8de7-92cf1264e307" providerId="ADAL" clId="{C4BBB0E8-4342-43A6-8BB1-18070781D58E}" dt="2023-08-03T22:34:40.972" v="9" actId="1037"/>
          <ac:picMkLst>
            <pc:docMk/>
            <pc:sldMk cId="3380178157" sldId="256"/>
            <ac:picMk id="5" creationId="{EFEBC194-0A90-49C5-8E29-FC9A97EC0775}"/>
          </ac:picMkLst>
        </pc:picChg>
      </pc:sldChg>
      <pc:sldMasterChg chg="modSp modSldLayout">
        <pc:chgData name="Mohiuddin, Sayed Golam" userId="5c5f2d06-5da7-4463-8de7-92cf1264e307" providerId="ADAL" clId="{C4BBB0E8-4342-43A6-8BB1-18070781D58E}" dt="2023-08-03T22:34:14.492" v="1"/>
        <pc:sldMasterMkLst>
          <pc:docMk/>
          <pc:sldMasterMk cId="441382263" sldId="2147483696"/>
        </pc:sldMasterMkLst>
        <pc:spChg chg="mod">
          <ac:chgData name="Mohiuddin, Sayed Golam" userId="5c5f2d06-5da7-4463-8de7-92cf1264e307" providerId="ADAL" clId="{C4BBB0E8-4342-43A6-8BB1-18070781D58E}" dt="2023-08-03T22:34:14.492" v="1"/>
          <ac:spMkLst>
            <pc:docMk/>
            <pc:sldMasterMk cId="441382263" sldId="2147483696"/>
            <ac:spMk id="2" creationId="{00000000-0000-0000-0000-000000000000}"/>
          </ac:spMkLst>
        </pc:spChg>
        <pc:spChg chg="mod">
          <ac:chgData name="Mohiuddin, Sayed Golam" userId="5c5f2d06-5da7-4463-8de7-92cf1264e307" providerId="ADAL" clId="{C4BBB0E8-4342-43A6-8BB1-18070781D58E}" dt="2023-08-03T22:34:14.492" v="1"/>
          <ac:spMkLst>
            <pc:docMk/>
            <pc:sldMasterMk cId="441382263" sldId="2147483696"/>
            <ac:spMk id="3" creationId="{00000000-0000-0000-0000-000000000000}"/>
          </ac:spMkLst>
        </pc:spChg>
        <pc:spChg chg="mod">
          <ac:chgData name="Mohiuddin, Sayed Golam" userId="5c5f2d06-5da7-4463-8de7-92cf1264e307" providerId="ADAL" clId="{C4BBB0E8-4342-43A6-8BB1-18070781D58E}" dt="2023-08-03T22:34:14.492" v="1"/>
          <ac:spMkLst>
            <pc:docMk/>
            <pc:sldMasterMk cId="441382263" sldId="2147483696"/>
            <ac:spMk id="4" creationId="{00000000-0000-0000-0000-000000000000}"/>
          </ac:spMkLst>
        </pc:spChg>
        <pc:spChg chg="mod">
          <ac:chgData name="Mohiuddin, Sayed Golam" userId="5c5f2d06-5da7-4463-8de7-92cf1264e307" providerId="ADAL" clId="{C4BBB0E8-4342-43A6-8BB1-18070781D58E}" dt="2023-08-03T22:34:14.492" v="1"/>
          <ac:spMkLst>
            <pc:docMk/>
            <pc:sldMasterMk cId="441382263" sldId="2147483696"/>
            <ac:spMk id="5" creationId="{00000000-0000-0000-0000-000000000000}"/>
          </ac:spMkLst>
        </pc:spChg>
        <pc:spChg chg="mod">
          <ac:chgData name="Mohiuddin, Sayed Golam" userId="5c5f2d06-5da7-4463-8de7-92cf1264e307" providerId="ADAL" clId="{C4BBB0E8-4342-43A6-8BB1-18070781D58E}" dt="2023-08-03T22:34:14.492" v="1"/>
          <ac:spMkLst>
            <pc:docMk/>
            <pc:sldMasterMk cId="441382263" sldId="2147483696"/>
            <ac:spMk id="6" creationId="{00000000-0000-0000-0000-000000000000}"/>
          </ac:spMkLst>
        </pc:sp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744073644" sldId="2147483697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744073644" sldId="2147483697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744073644" sldId="2147483697"/>
              <ac:spMk id="3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2261418215" sldId="2147483699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2261418215" sldId="2147483699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2261418215" sldId="2147483699"/>
              <ac:spMk id="3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3396079231" sldId="2147483700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3396079231" sldId="2147483700"/>
              <ac:spMk id="3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3396079231" sldId="2147483700"/>
              <ac:spMk id="4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844681983" sldId="2147483701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844681983" sldId="2147483701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844681983" sldId="2147483701"/>
              <ac:spMk id="3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844681983" sldId="2147483701"/>
              <ac:spMk id="4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844681983" sldId="2147483701"/>
              <ac:spMk id="5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844681983" sldId="2147483701"/>
              <ac:spMk id="6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2363243212" sldId="2147483704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2363243212" sldId="2147483704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2363243212" sldId="2147483704"/>
              <ac:spMk id="3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2363243212" sldId="2147483704"/>
              <ac:spMk id="4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1208085289" sldId="2147483705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1208085289" sldId="2147483705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1208085289" sldId="2147483705"/>
              <ac:spMk id="3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1208085289" sldId="2147483705"/>
              <ac:spMk id="4" creationId="{00000000-0000-0000-0000-000000000000}"/>
            </ac:spMkLst>
          </pc:spChg>
        </pc:sldLayoutChg>
        <pc:sldLayoutChg chg="modSp">
          <pc:chgData name="Mohiuddin, Sayed Golam" userId="5c5f2d06-5da7-4463-8de7-92cf1264e307" providerId="ADAL" clId="{C4BBB0E8-4342-43A6-8BB1-18070781D58E}" dt="2023-08-03T22:34:14.492" v="1"/>
          <pc:sldLayoutMkLst>
            <pc:docMk/>
            <pc:sldMasterMk cId="441382263" sldId="2147483696"/>
            <pc:sldLayoutMk cId="3827085774" sldId="2147483707"/>
          </pc:sldLayoutMkLst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3827085774" sldId="2147483707"/>
              <ac:spMk id="2" creationId="{00000000-0000-0000-0000-000000000000}"/>
            </ac:spMkLst>
          </pc:spChg>
          <pc:spChg chg="mod">
            <ac:chgData name="Mohiuddin, Sayed Golam" userId="5c5f2d06-5da7-4463-8de7-92cf1264e307" providerId="ADAL" clId="{C4BBB0E8-4342-43A6-8BB1-18070781D58E}" dt="2023-08-03T22:34:14.492" v="1"/>
            <ac:spMkLst>
              <pc:docMk/>
              <pc:sldMasterMk cId="441382263" sldId="2147483696"/>
              <pc:sldLayoutMk cId="3827085774" sldId="2147483707"/>
              <ac:spMk id="3" creationId="{00000000-0000-0000-0000-000000000000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244726"/>
            <a:ext cx="6217920" cy="477520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7204076"/>
            <a:ext cx="5486400" cy="3311524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165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767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730250"/>
            <a:ext cx="157734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730250"/>
            <a:ext cx="464058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027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832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3419479"/>
            <a:ext cx="6309360" cy="570547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9178929"/>
            <a:ext cx="6309360" cy="30003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792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3651250"/>
            <a:ext cx="310896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3651250"/>
            <a:ext cx="310896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032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730253"/>
            <a:ext cx="630936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3362326"/>
            <a:ext cx="3094672" cy="164782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5010150"/>
            <a:ext cx="3094672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3362326"/>
            <a:ext cx="3109913" cy="164782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5010150"/>
            <a:ext cx="3109913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79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501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584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914400"/>
            <a:ext cx="2359342" cy="32004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974853"/>
            <a:ext cx="3703320" cy="974725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114800"/>
            <a:ext cx="2359342" cy="762317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73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914400"/>
            <a:ext cx="2359342" cy="32004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974853"/>
            <a:ext cx="3703320" cy="974725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114800"/>
            <a:ext cx="2359342" cy="762317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91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730253"/>
            <a:ext cx="630936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3651250"/>
            <a:ext cx="630936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12712703"/>
            <a:ext cx="16459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03D48-D770-4A02-A2A5-22DE26F7AAFE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12712703"/>
            <a:ext cx="16459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A1AC1-1FD9-438A-906D-8A55CA319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21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flid_tracked_1">
            <a:hlinkClick r:id="" action="ppaction://media"/>
            <a:extLst>
              <a:ext uri="{FF2B5EF4-FFF2-40B4-BE49-F238E27FC236}">
                <a16:creationId xmlns:a16="http://schemas.microsoft.com/office/drawing/2014/main" id="{EFEBC194-0A90-49C5-8E29-FC9A97EC077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00022" y="6248406"/>
            <a:ext cx="6611814" cy="52867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D041CD-CC84-4981-B730-2DE437A59F01}"/>
              </a:ext>
            </a:extLst>
          </p:cNvPr>
          <p:cNvSpPr txBox="1"/>
          <p:nvPr/>
        </p:nvSpPr>
        <p:spPr>
          <a:xfrm>
            <a:off x="2754508" y="106683"/>
            <a:ext cx="25635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2400" i="1" dirty="0">
                <a:latin typeface="Arial" panose="020B0604020202020204" pitchFamily="34" charset="0"/>
                <a:cs typeface="Arial" panose="020B0604020202020204" pitchFamily="34" charset="0"/>
              </a:rPr>
              <a:t>fliD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(untracked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2948E1-3CC3-4C30-AB34-411CDA9C7A0B}"/>
              </a:ext>
            </a:extLst>
          </p:cNvPr>
          <p:cNvSpPr txBox="1"/>
          <p:nvPr/>
        </p:nvSpPr>
        <p:spPr>
          <a:xfrm>
            <a:off x="2926029" y="5697533"/>
            <a:ext cx="22204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2400" i="1" dirty="0">
                <a:latin typeface="Arial" panose="020B0604020202020204" pitchFamily="34" charset="0"/>
                <a:cs typeface="Arial" panose="020B0604020202020204" pitchFamily="34" charset="0"/>
              </a:rPr>
              <a:t>fliD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(tracked) </a:t>
            </a:r>
          </a:p>
        </p:txBody>
      </p:sp>
      <p:pic>
        <p:nvPicPr>
          <p:cNvPr id="2" name="flid_updated">
            <a:hlinkClick r:id="" action="ppaction://media"/>
            <a:extLst>
              <a:ext uri="{FF2B5EF4-FFF2-40B4-BE49-F238E27FC236}">
                <a16:creationId xmlns:a16="http://schemas.microsoft.com/office/drawing/2014/main" id="{87D1BEDB-1CDA-4830-9A5C-EDF80637D42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39530" y="657552"/>
            <a:ext cx="6176636" cy="487375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F1FF6E-DEC1-4B46-9D5F-5643F7DDD8BD}"/>
              </a:ext>
            </a:extLst>
          </p:cNvPr>
          <p:cNvSpPr txBox="1"/>
          <p:nvPr/>
        </p:nvSpPr>
        <p:spPr>
          <a:xfrm>
            <a:off x="70340" y="0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9D8E53-0110-47BF-B577-29B95CC09210}"/>
              </a:ext>
            </a:extLst>
          </p:cNvPr>
          <p:cNvSpPr txBox="1"/>
          <p:nvPr/>
        </p:nvSpPr>
        <p:spPr>
          <a:xfrm>
            <a:off x="70340" y="5608320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A20C70-D232-4B8D-92AA-3F4EDDEA3F19}"/>
              </a:ext>
            </a:extLst>
          </p:cNvPr>
          <p:cNvSpPr txBox="1"/>
          <p:nvPr/>
        </p:nvSpPr>
        <p:spPr>
          <a:xfrm>
            <a:off x="276021" y="11483927"/>
            <a:ext cx="6792086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vie S3. Representative movie of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aeruginos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Δ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i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in. (a-b)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tracked and tracked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aeruginos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Δ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iD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in, respectively. Single-cell tracking in panel “b”, highlighted in red circles, is performed using a MATLAB code. The tracked video is ~8 times slower than its original version (panel a). 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1781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668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36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</TotalTime>
  <Words>71</Words>
  <Application>Microsoft Office PowerPoint</Application>
  <PresentationFormat>Custom</PresentationFormat>
  <Paragraphs>5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iuddin, Sayed Golam</dc:creator>
  <cp:lastModifiedBy>Sayed Golam Mohiuddin</cp:lastModifiedBy>
  <cp:revision>8</cp:revision>
  <dcterms:created xsi:type="dcterms:W3CDTF">2023-07-19T00:29:59Z</dcterms:created>
  <dcterms:modified xsi:type="dcterms:W3CDTF">2024-10-17T21:02:55Z</dcterms:modified>
</cp:coreProperties>
</file>